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notesSlides/notesSlide5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888" r:id="rId2"/>
    <p:sldId id="886" r:id="rId3"/>
    <p:sldId id="882" r:id="rId4"/>
    <p:sldId id="883" r:id="rId5"/>
    <p:sldId id="884" r:id="rId6"/>
    <p:sldId id="885" r:id="rId7"/>
  </p:sldIdLst>
  <p:sldSz cx="12192000" cy="6858000"/>
  <p:notesSz cx="6802438" cy="99345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優香 三好" initials="優三" lastIdx="1" clrIdx="0">
    <p:extLst>
      <p:ext uri="{19B8F6BF-5375-455C-9EA6-DF929625EA0E}">
        <p15:presenceInfo xmlns:p15="http://schemas.microsoft.com/office/powerpoint/2012/main" userId="aed14cc4776ecae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4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335" autoAdjust="0"/>
    <p:restoredTop sz="68010" autoAdjust="0"/>
  </p:normalViewPr>
  <p:slideViewPr>
    <p:cSldViewPr snapToGrid="0">
      <p:cViewPr varScale="1">
        <p:scale>
          <a:sx n="60" d="100"/>
          <a:sy n="60" d="100"/>
        </p:scale>
        <p:origin x="26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8" d="100"/>
        <a:sy n="7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5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554778789897472E-2"/>
          <c:y val="0.15220329818869968"/>
          <c:w val="0.88427771129023769"/>
          <c:h val="0.684252770594574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23.6.4 (SD)太字のみ記入済'!$C$9</c:f>
              <c:strCache>
                <c:ptCount val="1"/>
                <c:pt idx="0">
                  <c:v>閉経前女性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EF5-40FB-B149-1D925C52E80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EF5-40FB-B149-1D925C52E80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EF5-40FB-B149-1D925C52E806}"/>
              </c:ext>
            </c:extLst>
          </c:dPt>
          <c:dLbls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23.6.4 (SD)太字のみ記入済'!$B$10:$B$13</c:f>
              <c:strCache>
                <c:ptCount val="4"/>
                <c:pt idx="0">
                  <c:v>機能正常</c:v>
                </c:pt>
                <c:pt idx="1">
                  <c:v>機能 3/4</c:v>
                </c:pt>
                <c:pt idx="2">
                  <c:v>機能 1/2</c:v>
                </c:pt>
                <c:pt idx="3">
                  <c:v>機能 1/4以下</c:v>
                </c:pt>
              </c:strCache>
            </c:strRef>
          </c:cat>
          <c:val>
            <c:numRef>
              <c:f>'2023.6.4 (SD)太字のみ記入済'!$C$10:$C$13</c:f>
              <c:numCache>
                <c:formatCode>0.00</c:formatCode>
                <c:ptCount val="4"/>
                <c:pt idx="0">
                  <c:v>4.0032189000000002</c:v>
                </c:pt>
                <c:pt idx="1">
                  <c:v>4.1510273</c:v>
                </c:pt>
                <c:pt idx="2">
                  <c:v>4.3311786999999997</c:v>
                </c:pt>
                <c:pt idx="3">
                  <c:v>4.3352940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E3-4F7B-BA1D-FF5C7AAC1EFE}"/>
            </c:ext>
          </c:extLst>
        </c:ser>
        <c:ser>
          <c:idx val="2"/>
          <c:order val="1"/>
          <c:tx>
            <c:strRef>
              <c:f>'2023.6.4 (SD)太字のみ記入済'!$E$9</c:f>
              <c:strCache>
                <c:ptCount val="1"/>
                <c:pt idx="0">
                  <c:v>閉経後女性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AEF5-40FB-B149-1D925C52E80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AEF5-40FB-B149-1D925C52E80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AEF5-40FB-B149-1D925C52E80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AEF5-40FB-B149-1D925C52E806}"/>
              </c:ext>
            </c:extLst>
          </c:dPt>
          <c:dLbls>
            <c:spPr>
              <a:solidFill>
                <a:schemeClr val="bg1"/>
              </a:solidFill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23.6.4 (SD)太字のみ記入済'!$B$10:$B$13</c:f>
              <c:strCache>
                <c:ptCount val="4"/>
                <c:pt idx="0">
                  <c:v>機能正常</c:v>
                </c:pt>
                <c:pt idx="1">
                  <c:v>機能 3/4</c:v>
                </c:pt>
                <c:pt idx="2">
                  <c:v>機能 1/2</c:v>
                </c:pt>
                <c:pt idx="3">
                  <c:v>機能 1/4以下</c:v>
                </c:pt>
              </c:strCache>
            </c:strRef>
          </c:cat>
          <c:val>
            <c:numRef>
              <c:f>'2023.6.4 (SD)太字のみ記入済'!$E$10:$E$13</c:f>
              <c:numCache>
                <c:formatCode>0.00</c:formatCode>
                <c:ptCount val="4"/>
                <c:pt idx="0">
                  <c:v>4.4924976000000001</c:v>
                </c:pt>
                <c:pt idx="1">
                  <c:v>4.6601328999999998</c:v>
                </c:pt>
                <c:pt idx="2">
                  <c:v>4.7295018999999998</c:v>
                </c:pt>
                <c:pt idx="3">
                  <c:v>5.128124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6E3-4F7B-BA1D-FF5C7AAC1EF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-268154048"/>
        <c:axId val="-268160576"/>
      </c:barChart>
      <c:catAx>
        <c:axId val="-2681540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ABCG2 function</a:t>
                </a:r>
              </a:p>
            </c:rich>
          </c:tx>
          <c:layout>
            <c:manualLayout>
              <c:xMode val="edge"/>
              <c:yMode val="edge"/>
              <c:x val="0.45465491463378566"/>
              <c:y val="0.949093874254132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68160576"/>
        <c:crosses val="autoZero"/>
        <c:auto val="1"/>
        <c:lblAlgn val="ctr"/>
        <c:lblOffset val="100"/>
        <c:noMultiLvlLbl val="0"/>
      </c:catAx>
      <c:valAx>
        <c:axId val="-268160576"/>
        <c:scaling>
          <c:orientation val="minMax"/>
          <c:max val="5.5"/>
          <c:min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SUA (mg/dl)</a:t>
                </a:r>
                <a:endParaRPr lang="ja-JP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68154048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5.1369683318001055E-2"/>
          <c:y val="0.1319121834120402"/>
          <c:w val="0.34432744005778931"/>
          <c:h val="9.91823485921843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bg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K$21</c:f>
              <c:strCache>
                <c:ptCount val="1"/>
                <c:pt idx="0">
                  <c:v>Heavy drinking</c:v>
                </c:pt>
              </c:strCache>
            </c:strRef>
          </c:tx>
          <c:spPr>
            <a:noFill/>
            <a:ln>
              <a:solidFill>
                <a:schemeClr val="tx1"/>
              </a:solidFill>
              <a:prstDash val="sysDash"/>
            </a:ln>
          </c:spPr>
          <c:dPt>
            <c:idx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1-4EDC-4BF9-B619-29B79C7FFDE1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3-4EDC-4BF9-B619-29B79C7FFDE1}"/>
              </c:ext>
            </c:extLst>
          </c:dPt>
          <c:dLbls>
            <c:dLbl>
              <c:idx val="0"/>
              <c:layout>
                <c:manualLayout>
                  <c:x val="0.18521632008096348"/>
                  <c:y val="0.1016121069744480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EDC-4BF9-B619-29B79C7FFDE1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9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4EDC-4BF9-B619-29B79C7FFDE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K$22:$K$23</c:f>
              <c:numCache>
                <c:formatCode>General</c:formatCode>
                <c:ptCount val="2"/>
                <c:pt idx="0">
                  <c:v>3.5</c:v>
                </c:pt>
                <c:pt idx="1">
                  <c:v>96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EDC-4BF9-B619-29B79C7FFD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900"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L$21</c:f>
              <c:strCache>
                <c:ptCount val="1"/>
                <c:pt idx="0">
                  <c:v>Overweight/obesity</c:v>
                </c:pt>
              </c:strCache>
            </c:strRef>
          </c:tx>
          <c:spPr>
            <a:noFill/>
          </c:spPr>
          <c:dPt>
            <c:idx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2EE-4DAD-AF3B-DB18A520CCB4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2EE-4DAD-AF3B-DB18A520CCB4}"/>
              </c:ext>
            </c:extLst>
          </c:dPt>
          <c:dLbls>
            <c:dLbl>
              <c:idx val="0"/>
              <c:layout>
                <c:manualLayout>
                  <c:x val="2.8242188835333127E-2"/>
                  <c:y val="6.0416666666666667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2EE-4DAD-AF3B-DB18A520CCB4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2EE-4DAD-AF3B-DB18A520CCB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/>
            </c:extLst>
          </c:dLbls>
          <c:val>
            <c:numRef>
              <c:f>Sheet1!$L$22:$L$23</c:f>
              <c:numCache>
                <c:formatCode>General</c:formatCode>
                <c:ptCount val="2"/>
                <c:pt idx="0">
                  <c:v>17.8</c:v>
                </c:pt>
                <c:pt idx="1">
                  <c:v>8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2EE-4DAD-AF3B-DB18A520CC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I$25</c:f>
              <c:strCache>
                <c:ptCount val="1"/>
                <c:pt idx="0">
                  <c:v>ABCG2 variant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FE2-404D-9433-02A3712A79D0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FE2-404D-9433-02A3712A79D0}"/>
              </c:ext>
            </c:extLst>
          </c:dPt>
          <c:dLbls>
            <c:dLbl>
              <c:idx val="0"/>
              <c:layout>
                <c:manualLayout>
                  <c:x val="-3.1574833312626831E-2"/>
                  <c:y val="-4.5541426212484894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FE2-404D-9433-02A3712A79D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val>
            <c:numRef>
              <c:f>Sheet1!$I$26:$I$27</c:f>
              <c:numCache>
                <c:formatCode>General</c:formatCode>
                <c:ptCount val="2"/>
                <c:pt idx="0">
                  <c:v>30.2</c:v>
                </c:pt>
                <c:pt idx="1">
                  <c:v>69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FE2-404D-9433-02A3712A79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J$25</c:f>
              <c:strCache>
                <c:ptCount val="1"/>
                <c:pt idx="0">
                  <c:v>Aging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C5C-4584-9A6D-23AA5178321C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3-4C5C-4584-9A6D-23AA5178321C}"/>
              </c:ext>
            </c:extLst>
          </c:dPt>
          <c:dLbls>
            <c:dLbl>
              <c:idx val="0"/>
              <c:layout>
                <c:manualLayout>
                  <c:x val="0.18062619395566387"/>
                  <c:y val="6.2696831962957292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C5C-4584-9A6D-23AA5178321C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C5C-4584-9A6D-23AA5178321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val>
            <c:numRef>
              <c:f>Sheet1!$J$26:$J$27</c:f>
              <c:numCache>
                <c:formatCode>General</c:formatCode>
                <c:ptCount val="2"/>
                <c:pt idx="0">
                  <c:v>1.89</c:v>
                </c:pt>
                <c:pt idx="1">
                  <c:v>98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C5C-4584-9A6D-23AA517832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K$25</c:f>
              <c:strCache>
                <c:ptCount val="1"/>
                <c:pt idx="0">
                  <c:v>Heavy drinking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dPt>
            <c:idx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478-445F-AFB5-BE1B1C8E61AE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478-445F-AFB5-BE1B1C8E61AE}"/>
              </c:ext>
            </c:extLst>
          </c:dPt>
          <c:dLbls>
            <c:dLbl>
              <c:idx val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4478-445F-AFB5-BE1B1C8E61AE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4478-445F-AFB5-BE1B1C8E61A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K$26:$K$27</c:f>
              <c:numCache>
                <c:formatCode>General</c:formatCode>
                <c:ptCount val="2"/>
                <c:pt idx="0">
                  <c:v>10.4</c:v>
                </c:pt>
                <c:pt idx="1">
                  <c:v>89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478-445F-AFB5-BE1B1C8E61AE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[グラフ用.xlsx]Sheet1!$L$25</c:f>
              <c:strCache>
                <c:ptCount val="1"/>
                <c:pt idx="0">
                  <c:v>Overweight/obesity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83F-4127-80DB-EE2FB2B8D791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83F-4127-80DB-EE2FB2B8D791}"/>
              </c:ext>
            </c:extLst>
          </c:dPt>
          <c:dLbls>
            <c:dLbl>
              <c:idx val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A83F-4127-80DB-EE2FB2B8D791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A83F-4127-80DB-EE2FB2B8D79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[グラフ用.xlsx]Sheet1!$L$26:$L$27</c:f>
              <c:numCache>
                <c:formatCode>General</c:formatCode>
                <c:ptCount val="2"/>
                <c:pt idx="0">
                  <c:v>14.9</c:v>
                </c:pt>
                <c:pt idx="1">
                  <c:v>85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83F-4127-80DB-EE2FB2B8D7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K$13</c:f>
              <c:strCache>
                <c:ptCount val="1"/>
                <c:pt idx="0">
                  <c:v>Heavy drinking</c:v>
                </c:pt>
              </c:strCache>
            </c:strRef>
          </c:tx>
          <c:spPr>
            <a:noFill/>
            <a:ln>
              <a:solidFill>
                <a:schemeClr val="tx1"/>
              </a:solidFill>
              <a:prstDash val="sysDash"/>
            </a:ln>
          </c:spPr>
          <c:explosion val="2"/>
          <c:dPt>
            <c:idx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1-B93A-49E8-8D4E-8C269014B3DD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3-B93A-49E8-8D4E-8C269014B3DD}"/>
              </c:ext>
            </c:extLst>
          </c:dPt>
          <c:dLbls>
            <c:dLbl>
              <c:idx val="0"/>
              <c:layout>
                <c:manualLayout>
                  <c:x val="0.19525521361424264"/>
                  <c:y val="0.11041666666666666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93A-49E8-8D4E-8C269014B3DD}"/>
                </c:ext>
              </c:extLst>
            </c:dLbl>
            <c:dLbl>
              <c:idx val="1"/>
              <c:layout>
                <c:manualLayout>
                  <c:x val="2.4645913291448975E-2"/>
                  <c:y val="-0.26541666666666669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2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93A-49E8-8D4E-8C269014B3D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K$14:$K$15</c:f>
              <c:numCache>
                <c:formatCode>General</c:formatCode>
                <c:ptCount val="2"/>
                <c:pt idx="0">
                  <c:v>-2.09</c:v>
                </c:pt>
                <c:pt idx="1">
                  <c:v>102.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93A-49E8-8D4E-8C269014B3DD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L$9</c:f>
              <c:strCache>
                <c:ptCount val="1"/>
                <c:pt idx="0">
                  <c:v>Overweight/obesity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dPt>
            <c:idx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994-4ECE-BAFC-9E99BDA0FDCB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994-4ECE-BAFC-9E99BDA0FDCB}"/>
              </c:ext>
            </c:extLst>
          </c:dPt>
          <c:dLbls>
            <c:dLbl>
              <c:idx val="0"/>
              <c:layout>
                <c:manualLayout>
                  <c:x val="4.0745260399583962E-2"/>
                  <c:y val="8.1240760340708443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994-4ECE-BAFC-9E99BDA0FDC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L$10:$L$11</c:f>
              <c:numCache>
                <c:formatCode>General</c:formatCode>
                <c:ptCount val="2"/>
                <c:pt idx="0">
                  <c:v>19.5</c:v>
                </c:pt>
                <c:pt idx="1">
                  <c:v>8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994-4ECE-BAFC-9E99BDA0FD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I$13</c:f>
              <c:strCache>
                <c:ptCount val="1"/>
                <c:pt idx="0">
                  <c:v>ABCG2 variants</c:v>
                </c:pt>
              </c:strCache>
            </c:strRef>
          </c:tx>
          <c:spPr>
            <a:solidFill>
              <a:srgbClr val="FFC000"/>
            </a:solidFill>
          </c:spPr>
          <c:dPt>
            <c:idx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A9A-4121-9C26-F2905A8C758B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A9A-4121-9C26-F2905A8C758B}"/>
              </c:ext>
            </c:extLst>
          </c:dPt>
          <c:dLbls>
            <c:dLbl>
              <c:idx val="0"/>
              <c:layout>
                <c:manualLayout>
                  <c:x val="-2.9235254580265907E-2"/>
                  <c:y val="0.25956523689329097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A9A-4121-9C26-F2905A8C758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I$14:$I$15</c:f>
              <c:numCache>
                <c:formatCode>0.0</c:formatCode>
                <c:ptCount val="2"/>
                <c:pt idx="0">
                  <c:v>45.8</c:v>
                </c:pt>
                <c:pt idx="1">
                  <c:v>5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A9A-4121-9C26-F2905A8C758B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I$9</c:f>
              <c:strCache>
                <c:ptCount val="1"/>
                <c:pt idx="0">
                  <c:v>ABCG2 variants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rgbClr val="92D050"/>
              </a:solidFill>
            </a:ln>
          </c:spPr>
          <c:dPt>
            <c:idx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13F-47FA-9A50-DCBCFEE130E2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13F-47FA-9A50-DCBCFEE130E2}"/>
              </c:ext>
            </c:extLst>
          </c:dPt>
          <c:dLbls>
            <c:dLbl>
              <c:idx val="0"/>
              <c:layout>
                <c:manualLayout>
                  <c:x val="4.568502298422164E-2"/>
                  <c:y val="0.11332574883344139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alt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13F-47FA-9A50-DCBCFEE130E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altLang="ja-JP" sz="12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I$10:$I$11</c:f>
              <c:numCache>
                <c:formatCode>0.0</c:formatCode>
                <c:ptCount val="2"/>
                <c:pt idx="0">
                  <c:v>32.799999999999997</c:v>
                </c:pt>
                <c:pt idx="1">
                  <c:v>67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13F-47FA-9A50-DCBCFEE130E2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lang="en-US" altLang="ja-JP"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J$9</c:f>
              <c:strCache>
                <c:ptCount val="1"/>
                <c:pt idx="0">
                  <c:v>Aging</c:v>
                </c:pt>
              </c:strCache>
            </c:strRef>
          </c:tx>
          <c:spPr>
            <a:ln>
              <a:solidFill>
                <a:srgbClr val="92D050"/>
              </a:solidFill>
            </a:ln>
          </c:spPr>
          <c:dPt>
            <c:idx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54C-43A4-8365-24487CC39983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54C-43A4-8365-24487CC39983}"/>
              </c:ext>
            </c:extLst>
          </c:dPt>
          <c:dLbls>
            <c:dLbl>
              <c:idx val="0"/>
              <c:layout>
                <c:manualLayout>
                  <c:x val="2.8877037794129548E-2"/>
                  <c:y val="0.1342523124845676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54C-43A4-8365-24487CC3998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val>
            <c:numRef>
              <c:f>Sheet1!$J$10:$J$11</c:f>
              <c:numCache>
                <c:formatCode>General</c:formatCode>
                <c:ptCount val="2"/>
                <c:pt idx="0">
                  <c:v>28.7</c:v>
                </c:pt>
                <c:pt idx="1">
                  <c:v>7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54C-43A4-8365-24487CC39983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K$9</c:f>
              <c:strCache>
                <c:ptCount val="1"/>
                <c:pt idx="0">
                  <c:v>Heavy drinking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dPt>
            <c:idx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1-C93E-489A-A274-04254D153B8A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  <a:prstDash val="sysDash"/>
              </a:ln>
              <a:effectLst/>
            </c:spPr>
            <c:extLst>
              <c:ext xmlns:c16="http://schemas.microsoft.com/office/drawing/2014/chart" uri="{C3380CC4-5D6E-409C-BE32-E72D297353CC}">
                <c16:uniqueId val="{00000003-C93E-489A-A274-04254D153B8A}"/>
              </c:ext>
            </c:extLst>
          </c:dPt>
          <c:dLbls>
            <c:dLbl>
              <c:idx val="0"/>
              <c:layout>
                <c:manualLayout>
                  <c:x val="0.26264901963191689"/>
                  <c:y val="8.5416666666666669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93E-489A-A274-04254D153B8A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C93E-489A-A274-04254D153B8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K$10:$K$11</c:f>
              <c:numCache>
                <c:formatCode>General</c:formatCode>
                <c:ptCount val="2"/>
                <c:pt idx="0" formatCode="0.00">
                  <c:v>-1.03</c:v>
                </c:pt>
                <c:pt idx="1">
                  <c:v>101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93E-489A-A274-04254D153B8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M$9</c:f>
              <c:strCache>
                <c:ptCount val="1"/>
                <c:pt idx="0">
                  <c:v>mens</c:v>
                </c:pt>
              </c:strCache>
            </c:strRef>
          </c:tx>
          <c:dPt>
            <c:idx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E6C-4183-9A7D-47E586E72234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E6C-4183-9A7D-47E586E72234}"/>
              </c:ext>
            </c:extLst>
          </c:dPt>
          <c:dLbls>
            <c:dLbl>
              <c:idx val="0"/>
              <c:layout>
                <c:manualLayout>
                  <c:x val="-4.8485557726579025E-2"/>
                  <c:y val="0.18000851165245221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E6C-4183-9A7D-47E586E7223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val>
            <c:numRef>
              <c:f>Sheet1!$M$10:$M$11</c:f>
              <c:numCache>
                <c:formatCode>0.00</c:formatCode>
                <c:ptCount val="2"/>
                <c:pt idx="0" formatCode="0.0">
                  <c:v>63</c:v>
                </c:pt>
                <c:pt idx="1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E6C-4183-9A7D-47E586E72234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L$13</c:f>
              <c:strCache>
                <c:ptCount val="1"/>
                <c:pt idx="0">
                  <c:v>Overweight/obesity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0E1-4BDE-8F45-51625AB9EC78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0E1-4BDE-8F45-51625AB9EC78}"/>
              </c:ext>
            </c:extLst>
          </c:dPt>
          <c:dLbls>
            <c:dLbl>
              <c:idx val="0"/>
              <c:layout>
                <c:manualLayout>
                  <c:x val="2.4700929823354499E-2"/>
                  <c:y val="7.2654887584934852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0E1-4BDE-8F45-51625AB9EC78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A0E1-4BDE-8F45-51625AB9EC7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L$14:$L$15</c:f>
              <c:numCache>
                <c:formatCode>General</c:formatCode>
                <c:ptCount val="2"/>
                <c:pt idx="0">
                  <c:v>25.1</c:v>
                </c:pt>
                <c:pt idx="1">
                  <c:v>74.9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0E1-4BDE-8F45-51625AB9EC78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I$21</c:f>
              <c:strCache>
                <c:ptCount val="1"/>
                <c:pt idx="0">
                  <c:v>ABCG2 variants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3C-4F36-8CBF-EE78DD4D9A63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3C-4F36-8CBF-EE78DD4D9A63}"/>
              </c:ext>
            </c:extLst>
          </c:dPt>
          <c:dLbls>
            <c:dLbl>
              <c:idx val="0"/>
              <c:layout>
                <c:manualLayout>
                  <c:x val="9.6274596350867415E-3"/>
                  <c:y val="3.0198818897637775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43C-4F36-8CBF-EE78DD4D9A63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bg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143C-4F36-8CBF-EE78DD4D9A6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I$22:$I$23</c:f>
              <c:numCache>
                <c:formatCode>General</c:formatCode>
                <c:ptCount val="2"/>
                <c:pt idx="0">
                  <c:v>29.6</c:v>
                </c:pt>
                <c:pt idx="1">
                  <c:v>70.4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3C-4F36-8CBF-EE78DD4D9A63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J$21</c:f>
              <c:strCache>
                <c:ptCount val="1"/>
                <c:pt idx="0">
                  <c:v>Aging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055-4048-8D67-C04674BFC13D}"/>
              </c:ext>
            </c:extLst>
          </c:dPt>
          <c:dPt>
            <c:idx val="1"/>
            <c:bubble3D val="0"/>
            <c:spPr>
              <a:noFill/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055-4048-8D67-C04674BFC13D}"/>
              </c:ext>
            </c:extLst>
          </c:dPt>
          <c:dLbls>
            <c:dLbl>
              <c:idx val="0"/>
              <c:layout>
                <c:manualLayout>
                  <c:x val="4.4838627941189667E-2"/>
                  <c:y val="0.10215140527381986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055-4048-8D67-C04674BFC13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2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val>
            <c:numRef>
              <c:f>Sheet1!$J$22:$J$23</c:f>
              <c:numCache>
                <c:formatCode>General</c:formatCode>
                <c:ptCount val="2"/>
                <c:pt idx="0">
                  <c:v>15.4</c:v>
                </c:pt>
                <c:pt idx="1">
                  <c:v>8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055-4048-8D67-C04674BFC13D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137</cdr:x>
      <cdr:y>0.23059</cdr:y>
    </cdr:from>
    <cdr:to>
      <cdr:x>0.53067</cdr:x>
      <cdr:y>0.34318</cdr:y>
    </cdr:to>
    <cdr:sp macro="" textlink="">
      <cdr:nvSpPr>
        <cdr:cNvPr id="3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6BC0694E-4FEF-871B-7E66-DE27F4EB0771}"/>
            </a:ext>
          </a:extLst>
        </cdr:cNvPr>
        <cdr:cNvSpPr txBox="1"/>
      </cdr:nvSpPr>
      <cdr:spPr>
        <a:xfrm xmlns:a="http://schemas.openxmlformats.org/drawingml/2006/main">
          <a:off x="3474894" y="1260664"/>
          <a:ext cx="2643863" cy="61555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kumimoji="1" lang="el-GR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β</a:t>
          </a:r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= 0.51</a:t>
          </a:r>
        </a:p>
        <a:p xmlns:a="http://schemas.openxmlformats.org/drawingml/2006/main">
          <a:pPr algn="ctr"/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(p&lt; 0.0001</a:t>
          </a:r>
          <a:r>
            <a:rPr kumimoji="1" lang="ja-JP" altLang="en-US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）</a:t>
          </a:r>
          <a:endParaRPr kumimoji="1" lang="en-US" altLang="ja-JP" sz="17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3067</cdr:x>
      <cdr:y>0.18475</cdr:y>
    </cdr:from>
    <cdr:to>
      <cdr:x>0.76234</cdr:x>
      <cdr:y>0.29734</cdr:y>
    </cdr:to>
    <cdr:sp macro="" textlink="">
      <cdr:nvSpPr>
        <cdr:cNvPr id="5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6BC0694E-4FEF-871B-7E66-DE27F4EB0771}"/>
            </a:ext>
          </a:extLst>
        </cdr:cNvPr>
        <cdr:cNvSpPr txBox="1"/>
      </cdr:nvSpPr>
      <cdr:spPr>
        <a:xfrm xmlns:a="http://schemas.openxmlformats.org/drawingml/2006/main">
          <a:off x="6118757" y="1010037"/>
          <a:ext cx="2671189" cy="61555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β = </a:t>
          </a:r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0.40</a:t>
          </a:r>
        </a:p>
        <a:p xmlns:a="http://schemas.openxmlformats.org/drawingml/2006/main">
          <a:pPr algn="ctr"/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(p&lt; 0.0001)</a:t>
          </a:r>
        </a:p>
      </cdr:txBody>
    </cdr:sp>
  </cdr:relSizeAnchor>
  <cdr:relSizeAnchor xmlns:cdr="http://schemas.openxmlformats.org/drawingml/2006/chartDrawing">
    <cdr:from>
      <cdr:x>0.13233</cdr:x>
      <cdr:y>0.85786</cdr:y>
    </cdr:from>
    <cdr:to>
      <cdr:x>0.94895</cdr:x>
      <cdr:y>0.91979</cdr:y>
    </cdr:to>
    <cdr:sp macro="" textlink="">
      <cdr:nvSpPr>
        <cdr:cNvPr id="4" name="テキスト ボックス 9">
          <a:extLst xmlns:a="http://schemas.openxmlformats.org/drawingml/2006/main">
            <a:ext uri="{FF2B5EF4-FFF2-40B4-BE49-F238E27FC236}">
              <a16:creationId xmlns:a16="http://schemas.microsoft.com/office/drawing/2014/main" id="{81454C64-6EFC-5F0B-A0E3-9371CCE0CA92}"/>
            </a:ext>
          </a:extLst>
        </cdr:cNvPr>
        <cdr:cNvSpPr txBox="1"/>
      </cdr:nvSpPr>
      <cdr:spPr>
        <a:xfrm xmlns:a="http://schemas.openxmlformats.org/drawingml/2006/main">
          <a:off x="1525784" y="4690025"/>
          <a:ext cx="9415749" cy="338554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US" altLang="ja-JP" sz="1600" dirty="0">
              <a:latin typeface="Arial" panose="020B0604020202020204" pitchFamily="34" charset="0"/>
              <a:cs typeface="Arial" panose="020B0604020202020204" pitchFamily="34" charset="0"/>
            </a:rPr>
            <a:t>full</a:t>
          </a:r>
          <a:r>
            <a: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rPr>
            <a:t>  function                          3/4 function                           1/2 function                           </a:t>
          </a:r>
          <a:r>
            <a:rPr kumimoji="1" lang="en-US" altLang="ja-JP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≤</a:t>
          </a:r>
          <a:r>
            <a: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rPr>
            <a:t>1/4 function</a:t>
          </a:r>
        </a:p>
      </cdr:txBody>
    </cdr:sp>
  </cdr:relSizeAnchor>
  <cdr:relSizeAnchor xmlns:cdr="http://schemas.openxmlformats.org/drawingml/2006/chartDrawing">
    <cdr:from>
      <cdr:x>0.08771</cdr:x>
      <cdr:y>0.28004</cdr:y>
    </cdr:from>
    <cdr:to>
      <cdr:x>0.30776</cdr:x>
      <cdr:y>0.39263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6BC0694E-4FEF-871B-7E66-DE27F4EB0771}"/>
            </a:ext>
          </a:extLst>
        </cdr:cNvPr>
        <cdr:cNvSpPr txBox="1"/>
      </cdr:nvSpPr>
      <cdr:spPr>
        <a:xfrm xmlns:a="http://schemas.openxmlformats.org/drawingml/2006/main">
          <a:off x="1011252" y="1531030"/>
          <a:ext cx="2537209" cy="61555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β </a:t>
          </a:r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= 0.49 </a:t>
          </a:r>
        </a:p>
        <a:p xmlns:a="http://schemas.openxmlformats.org/drawingml/2006/main">
          <a:pPr algn="ctr"/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(</a:t>
          </a:r>
          <a:r>
            <a:rPr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&lt; 0.0001</a:t>
          </a:r>
          <a:r>
            <a:rPr kumimoji="1" lang="en-US" altLang="ja-JP" sz="1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)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03C347-989B-43FE-8B02-E363D74966E9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947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ED5A7A-45C9-4F41-8885-668BA4F230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42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６</a:t>
            </a:r>
            <a:r>
              <a:rPr kumimoji="0" lang="en-US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. Nakayama A, Matsuo H, </a:t>
            </a:r>
            <a:r>
              <a:rPr kumimoji="0" lang="en-US" altLang="ja-JP" sz="2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akaoka</a:t>
            </a:r>
            <a:r>
              <a:rPr kumimoji="0" lang="en-US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H, Nakamura T, Nakashima H, Takada Y, et al. Common dysfunctional variants of ABCG2 have stronger impact on hyperuricemia progression than typical environmental risk factors. Sci Rep. 2014;4:5227. </a:t>
            </a:r>
            <a:r>
              <a:rPr kumimoji="0" lang="en-US" altLang="ja-JP" sz="2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doi</a:t>
            </a:r>
            <a:r>
              <a:rPr kumimoji="0" lang="en-US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: 10.1038/srep05227.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ED5A7A-45C9-4F41-8885-668BA4F2300B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9014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fld id="{4048CBAE-65BB-4F03-9852-ACAA9283D29A}" type="datetime1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1B6342-BDCF-428B-A047-E0A18F8D1D88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2294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sz="1200" b="0" dirty="0">
              <a:solidFill>
                <a:schemeClr val="tx1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ED5A7A-45C9-4F41-8885-668BA4F2300B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6407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>
              <a:solidFill>
                <a:srgbClr val="00B050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1A8A98-5117-4FF9-A2D8-8A470CE8A767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24378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fld id="{F7E9BB8D-BC77-4E16-ADD4-F5032EA8BAF5}" type="datetime1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1B6342-BDCF-428B-A047-E0A18F8D1D88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1009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653C2-F190-4CEA-5DFA-7B5C20C1FA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4216989-08B1-37FA-3015-6973674A4F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6EBAA0-B7A0-D5D4-D5F4-E89C8B341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3C1044-B3B3-E934-BC40-51E8302F1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D2DB2F-11F3-B8EC-A9D2-92726F850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320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EBD112-5DE4-EBE1-C2A3-F347570DE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1E2FE08-9DB3-A7DF-EDAE-78549E07E9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C0A61A-A9AC-B48C-1B71-6E624D85C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1D87EF-2555-44A9-60DA-80BFC4F03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1CCA0C-D645-8D70-B6AF-1BDAEDFF8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412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49BA179-FD8C-C752-6F75-895FBB35B3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A13E8C3-79F0-0704-56DD-36D26AD921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5D54CA-8BAD-E9C5-ADE3-9D85FED76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DA10C2-93FC-BCEA-0F8B-1A742FDED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A75AB1-23CA-F3D3-2FF5-FE6058183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36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025D25-D526-FD58-F99F-BF24A5FDD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E0FF63C-A91A-F2B8-79FD-E3D934341A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19C980-96AE-DBC9-3B15-04A929FB2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E485B4-FF01-B6BF-69D3-0C7AB3FF9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F8BF49-B9E6-A7CB-5EC0-F1F3E456A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950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2ED2EC-D2A1-E9A2-6980-CECD0090B4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AFD24F-D606-C6B2-DA33-5B385C07DC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73FE7FB-BCD8-03A0-D22F-473E21C5B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49A3B5-CC67-BD25-9919-EDDB82DEE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E48479-9182-60E7-CE12-701167BB6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421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F71882-ED07-9125-9695-05504AE055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8EE5E6D-A6D5-82A1-8398-63FB2A3E06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8F0EED2-A3A3-4B15-84DE-184C7C89A6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B3FF92A-FD6E-66BE-070C-3224C715E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F5163A9-C218-D605-3C83-9409EA2AD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CEE5E8E-E04A-D944-FCC4-6BD86F5E8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AA365E-1686-0853-91D9-B69BCB5CE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B38FD7-9683-39BA-D91B-FF42DDCF0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741349-27DD-467E-3E82-2EA3E1B7EC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B6BBB64-BBF2-8A3F-9885-70C29DC5ED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DD6BC33-F870-FA40-C1DD-39D985D93C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D358334-8462-4E0F-8E00-DB6365764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CFDD498-C5BF-6C32-8AE0-A8A5A25CD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8D9A4ED-C3D1-3DFC-FC36-93A715F95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6519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47560C-8FA1-21B7-37EF-0ED7BCAF1F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82D231B-8B32-5DA4-933C-79442779D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60469AE-6BAB-B3E3-C743-E0D8CB236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DDA1828-D68B-EE26-936A-3D69EDF43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4038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6693AB4-35AB-7C95-34F9-EFF0A077D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BD2DC7E-E314-018B-0CAA-F349F1C67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5515591-5DF7-F4B3-54D4-C88C99DCD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79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CC3974-98A4-7AF7-C8FE-8595F46C1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3509C13-E672-38B8-5451-A15DC0A400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F5FDDF2-78AD-5058-E54B-9699CE5BAD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931440F-7EA1-A357-4A55-96EEB56E5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80D14A3-73A7-54DC-9E6B-6A516FABB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6AB2E7-A4B9-AAE9-1A20-74DB9809F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622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F68EC1-69EA-9E25-918D-A39E1C56CB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3CB1E8-026A-18F3-2C9C-1A03670543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17E7A30-9B94-7D6D-55E2-BC174286E7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DF68D75-83AF-FFB8-0194-13B77DBBD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61CCC0-86AE-7F9C-233C-914622B05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565E01-87CF-79AC-7E53-FD9F4C8F5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506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2890C83-08CB-0DFF-7577-8B40596CE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EF8910-A5D8-604B-B53B-ABBBF0C15E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7EE4EE-80F0-5381-FC37-6257FD84AA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DB629-7E7A-421B-9D55-34319ABCEBCD}" type="datetimeFigureOut">
              <a:rPr kumimoji="1" lang="ja-JP" altLang="en-US" smtClean="0"/>
              <a:t>2026/4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0C30E1-27F9-1EE0-5607-0F68036052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DB887B-8699-F384-79CF-C970BAE0FE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85B2D-3706-4137-A7DE-61B38B9497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8232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notesSlide" Target="../notesSlides/notesSlide5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62E5A4-584C-2F9F-2363-8A26A3D28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br>
              <a:rPr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682D83-38D6-2929-033F-F263D3BE3B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345096"/>
            <a:ext cx="10515600" cy="4831867"/>
          </a:xfrm>
        </p:spPr>
        <p:txBody>
          <a:bodyPr>
            <a:normAutofit fontScale="55000" lnSpcReduction="20000"/>
          </a:bodyPr>
          <a:lstStyle/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sz="3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tle: </a:t>
            </a:r>
            <a:r>
              <a:rPr lang="en-US" altLang="ja-JP" sz="3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s of ABCG2 dysfunction on hyperuricemia progression in premenopausal and postmenopausal females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thors:</a:t>
            </a:r>
            <a:endParaRPr kumimoji="1"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uka Miyoshi, Akiyoshi Nakayama, Hiroshi Nakashima, et al.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ence to H. Matsuo (email: matsuo29@gmail.com).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S1: Conversion table of alcohol consumption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S2: Characteristics of participants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: Serum uric acid (SUA) in each ABCG2 functional group estimated from the combination   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</a:t>
            </a: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dysfunctional variants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1: Effects of menopause on serum uric acid (SUA) levels of women for each ABCG2                                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</a:t>
            </a: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endPara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lnSpc>
                <a:spcPct val="120000"/>
              </a:lnSpc>
              <a:spcBef>
                <a:spcPts val="0"/>
              </a:spcBef>
              <a:buNone/>
            </a:pPr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2: PAF of each risk factor for hyperuricemia progression</a:t>
            </a:r>
            <a:endParaRPr kumimoji="1" lang="ja-JP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0EF8F526-F3F5-29C6-462D-EB0DA97FF109}"/>
              </a:ext>
            </a:extLst>
          </p:cNvPr>
          <p:cNvCxnSpPr/>
          <p:nvPr/>
        </p:nvCxnSpPr>
        <p:spPr>
          <a:xfrm>
            <a:off x="838200" y="3429000"/>
            <a:ext cx="105156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25290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D2AE44-757F-31A4-0A01-104DC2D7AD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1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: </a:t>
            </a:r>
            <a:r>
              <a:rPr kumimoji="0" lang="en-US" altLang="ja-JP" sz="1800" b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onversion table of alcohol consumption</a:t>
            </a:r>
            <a:endParaRPr kumimoji="1" lang="ja-JP" altLang="en-US" sz="1800" dirty="0"/>
          </a:p>
        </p:txBody>
      </p:sp>
      <p:graphicFrame>
        <p:nvGraphicFramePr>
          <p:cNvPr id="10" name="コンテンツ プレースホルダー 9">
            <a:extLst>
              <a:ext uri="{FF2B5EF4-FFF2-40B4-BE49-F238E27FC236}">
                <a16:creationId xmlns:a16="http://schemas.microsoft.com/office/drawing/2014/main" id="{30C10976-2544-C941-B436-D67795C89C75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917204" y="1262747"/>
          <a:ext cx="8168739" cy="3802967"/>
        </p:xfrm>
        <a:graphic>
          <a:graphicData uri="http://schemas.openxmlformats.org/drawingml/2006/table">
            <a:tbl>
              <a:tblPr firstRow="1" firstCol="1" bandRow="1"/>
              <a:tblGrid>
                <a:gridCol w="1963882">
                  <a:extLst>
                    <a:ext uri="{9D8B030D-6E8A-4147-A177-3AD203B41FA5}">
                      <a16:colId xmlns:a16="http://schemas.microsoft.com/office/drawing/2014/main" val="1083273947"/>
                    </a:ext>
                  </a:extLst>
                </a:gridCol>
                <a:gridCol w="3306886">
                  <a:extLst>
                    <a:ext uri="{9D8B030D-6E8A-4147-A177-3AD203B41FA5}">
                      <a16:colId xmlns:a16="http://schemas.microsoft.com/office/drawing/2014/main" val="4273593404"/>
                    </a:ext>
                  </a:extLst>
                </a:gridCol>
                <a:gridCol w="2897971">
                  <a:extLst>
                    <a:ext uri="{9D8B030D-6E8A-4147-A177-3AD203B41FA5}">
                      <a16:colId xmlns:a16="http://schemas.microsoft.com/office/drawing/2014/main" val="3599649857"/>
                    </a:ext>
                  </a:extLst>
                </a:gridCol>
              </a:tblGrid>
              <a:tr h="633827">
                <a:tc>
                  <a:txBody>
                    <a:bodyPr/>
                    <a:lstStyle/>
                    <a:p>
                      <a:pPr algn="l"/>
                      <a:endParaRPr lang="en-US" sz="18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lcoholic drinks</a:t>
                      </a:r>
                      <a:endParaRPr lang="ja-JP" sz="18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mount</a:t>
                      </a:r>
                      <a:endParaRPr lang="ja-JP" sz="18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lcohol consumption</a:t>
                      </a:r>
                      <a:endParaRPr lang="ja-JP" sz="18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b="1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(grams of pure alcohol)</a:t>
                      </a:r>
                      <a:endParaRPr lang="ja-JP" sz="18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4233025"/>
                  </a:ext>
                </a:extLst>
              </a:tr>
              <a:tr h="316914">
                <a:tc rowSpan="2"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Whiskey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single shot (= 30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0334547"/>
                  </a:ext>
                </a:extLst>
              </a:tr>
              <a:tr h="31691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double shot (= 60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20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188410"/>
                  </a:ext>
                </a:extLst>
              </a:tr>
              <a:tr h="316914"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Wine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glass (=120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2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8375199"/>
                  </a:ext>
                </a:extLst>
              </a:tr>
              <a:tr h="316914">
                <a:tc rowSpan="4"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Beer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large-sized bottle (= 633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25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4884344"/>
                  </a:ext>
                </a:extLst>
              </a:tr>
              <a:tr h="31691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mid-sized bottle (= 500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20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845843"/>
                  </a:ext>
                </a:extLst>
              </a:tr>
              <a:tr h="31691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can of 350 ml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4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8152492"/>
                  </a:ext>
                </a:extLst>
              </a:tr>
              <a:tr h="31691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a can of 250 ml or less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7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4889697"/>
                  </a:ext>
                </a:extLst>
              </a:tr>
              <a:tr h="316914"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Japanese sake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 gou (= 180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22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5908360"/>
                  </a:ext>
                </a:extLst>
              </a:tr>
              <a:tr h="316914"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Shochu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 gou (= 180 ml)</a:t>
                      </a:r>
                      <a:endParaRPr lang="ja-JP" sz="18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7416205"/>
                  </a:ext>
                </a:extLst>
              </a:tr>
              <a:tr h="316914"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Shochu highball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 glass (= 350 ml)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20</a:t>
                      </a:r>
                      <a:endParaRPr lang="ja-JP" sz="18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5822297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0A8C6AD-20E5-504E-A931-91BD782DD412}"/>
              </a:ext>
            </a:extLst>
          </p:cNvPr>
          <p:cNvSpPr txBox="1"/>
          <p:nvPr/>
        </p:nvSpPr>
        <p:spPr>
          <a:xfrm>
            <a:off x="847353" y="5133588"/>
            <a:ext cx="830843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eferred </a:t>
            </a:r>
            <a:r>
              <a:rPr kumimoji="0" lang="en-US" altLang="ja-JP" sz="18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rom Ref. 6 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n the main text under the terms of the Creative Commons Attribution-</a:t>
            </a:r>
            <a:r>
              <a:rPr kumimoji="0" lang="en-US" altLang="ja-JP" sz="1800" b="0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NonCommercial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</a:t>
            </a:r>
            <a:r>
              <a:rPr kumimoji="0" lang="en-US" altLang="ja-JP" sz="1800" b="0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NoDerivs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3.0 </a:t>
            </a:r>
            <a:r>
              <a:rPr kumimoji="0" lang="en-US" altLang="ja-JP" sz="1800" b="0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Unported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License (https://creativecommons.org/licenses/by-nc-nd/3.0/).</a:t>
            </a:r>
          </a:p>
        </p:txBody>
      </p:sp>
    </p:spTree>
    <p:extLst>
      <p:ext uri="{BB962C8B-B14F-4D97-AF65-F5344CB8AC3E}">
        <p14:creationId xmlns:p14="http://schemas.microsoft.com/office/powerpoint/2010/main" val="2779951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1E03782-EC33-FC60-EE5B-748314426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B9AE-3D0A-45F5-8F0B-3E4713A3ED06}" type="slidenum">
              <a:rPr kumimoji="1" lang="ja-JP" altLang="en-US" smtClean="0">
                <a:solidFill>
                  <a:schemeClr val="tx1"/>
                </a:solidFill>
              </a:rPr>
              <a:t>3</a:t>
            </a:fld>
            <a:endParaRPr kumimoji="1" lang="ja-JP" altLang="en-US">
              <a:solidFill>
                <a:schemeClr val="tx1"/>
              </a:solidFill>
            </a:endParaRPr>
          </a:p>
        </p:txBody>
      </p:sp>
      <p:graphicFrame>
        <p:nvGraphicFramePr>
          <p:cNvPr id="9" name="コンテンツ プレースホルダー 5">
            <a:extLst>
              <a:ext uri="{FF2B5EF4-FFF2-40B4-BE49-F238E27FC236}">
                <a16:creationId xmlns:a16="http://schemas.microsoft.com/office/drawing/2014/main" id="{1B3AD276-0CA2-63F3-934B-ADA3B4925E7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31473219"/>
              </p:ext>
            </p:extLst>
          </p:nvPr>
        </p:nvGraphicFramePr>
        <p:xfrm>
          <a:off x="867266" y="1035332"/>
          <a:ext cx="9564348" cy="4115644"/>
        </p:xfrm>
        <a:graphic>
          <a:graphicData uri="http://schemas.openxmlformats.org/drawingml/2006/table">
            <a:tbl>
              <a:tblPr/>
              <a:tblGrid>
                <a:gridCol w="3258557">
                  <a:extLst>
                    <a:ext uri="{9D8B030D-6E8A-4147-A177-3AD203B41FA5}">
                      <a16:colId xmlns:a16="http://schemas.microsoft.com/office/drawing/2014/main" val="2548197085"/>
                    </a:ext>
                  </a:extLst>
                </a:gridCol>
                <a:gridCol w="97790">
                  <a:extLst>
                    <a:ext uri="{9D8B030D-6E8A-4147-A177-3AD203B41FA5}">
                      <a16:colId xmlns:a16="http://schemas.microsoft.com/office/drawing/2014/main" val="1573438490"/>
                    </a:ext>
                  </a:extLst>
                </a:gridCol>
                <a:gridCol w="1287652">
                  <a:extLst>
                    <a:ext uri="{9D8B030D-6E8A-4147-A177-3AD203B41FA5}">
                      <a16:colId xmlns:a16="http://schemas.microsoft.com/office/drawing/2014/main" val="93382211"/>
                    </a:ext>
                  </a:extLst>
                </a:gridCol>
                <a:gridCol w="97790">
                  <a:extLst>
                    <a:ext uri="{9D8B030D-6E8A-4147-A177-3AD203B41FA5}">
                      <a16:colId xmlns:a16="http://schemas.microsoft.com/office/drawing/2014/main" val="4262319059"/>
                    </a:ext>
                  </a:extLst>
                </a:gridCol>
                <a:gridCol w="1420595">
                  <a:extLst>
                    <a:ext uri="{9D8B030D-6E8A-4147-A177-3AD203B41FA5}">
                      <a16:colId xmlns:a16="http://schemas.microsoft.com/office/drawing/2014/main" val="338991589"/>
                    </a:ext>
                  </a:extLst>
                </a:gridCol>
                <a:gridCol w="97790">
                  <a:extLst>
                    <a:ext uri="{9D8B030D-6E8A-4147-A177-3AD203B41FA5}">
                      <a16:colId xmlns:a16="http://schemas.microsoft.com/office/drawing/2014/main" val="4148151799"/>
                    </a:ext>
                  </a:extLst>
                </a:gridCol>
                <a:gridCol w="1534511">
                  <a:extLst>
                    <a:ext uri="{9D8B030D-6E8A-4147-A177-3AD203B41FA5}">
                      <a16:colId xmlns:a16="http://schemas.microsoft.com/office/drawing/2014/main" val="189113133"/>
                    </a:ext>
                  </a:extLst>
                </a:gridCol>
                <a:gridCol w="100811">
                  <a:extLst>
                    <a:ext uri="{9D8B030D-6E8A-4147-A177-3AD203B41FA5}">
                      <a16:colId xmlns:a16="http://schemas.microsoft.com/office/drawing/2014/main" val="3764477591"/>
                    </a:ext>
                  </a:extLst>
                </a:gridCol>
                <a:gridCol w="1668852">
                  <a:extLst>
                    <a:ext uri="{9D8B030D-6E8A-4147-A177-3AD203B41FA5}">
                      <a16:colId xmlns:a16="http://schemas.microsoft.com/office/drawing/2014/main" val="3258252549"/>
                    </a:ext>
                  </a:extLst>
                </a:gridCol>
              </a:tblGrid>
              <a:tr h="35639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omen </a:t>
                      </a:r>
                      <a:endParaRPr lang="ja-JP" altLang="en-US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2000" b="0" kern="1200" dirty="0">
                          <a:solidFill>
                            <a:srgbClr val="000000"/>
                          </a:solidFill>
                          <a:effectLst/>
                          <a:latin typeface="+mn-ea"/>
                          <a:ea typeface="+mn-ea"/>
                        </a:rPr>
                        <a:t> </a:t>
                      </a:r>
                      <a:endParaRPr lang="ja-JP" sz="2000" b="0" kern="100" dirty="0">
                        <a:effectLst/>
                        <a:latin typeface="+mn-ea"/>
                        <a:ea typeface="+mn-ea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2000" b="0" kern="1200" dirty="0">
                          <a:solidFill>
                            <a:schemeClr val="tx1"/>
                          </a:solidFill>
                          <a:effectLst/>
                          <a:latin typeface="+mn-ea"/>
                          <a:ea typeface="+mn-ea"/>
                        </a:rPr>
                        <a:t> </a:t>
                      </a:r>
                      <a:endParaRPr lang="ja-JP" sz="2000" b="0" kern="100" dirty="0">
                        <a:solidFill>
                          <a:schemeClr val="tx1"/>
                        </a:solidFill>
                        <a:effectLst/>
                        <a:latin typeface="+mn-ea"/>
                        <a:ea typeface="+mn-ea"/>
                      </a:endParaRPr>
                    </a:p>
                  </a:txBody>
                  <a:tcPr marL="36195" marR="36195" marT="0" marB="0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kern="1200" dirty="0">
                        <a:solidFill>
                          <a:schemeClr val="tx1"/>
                        </a:solidFill>
                        <a:effectLst/>
                        <a:latin typeface="+mn-ea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2000" b="0" kern="1200" dirty="0">
                          <a:solidFill>
                            <a:schemeClr val="tx1"/>
                          </a:solidFill>
                          <a:effectLst/>
                          <a:latin typeface="+mn-ea"/>
                          <a:ea typeface="+mn-ea"/>
                          <a:cs typeface="Arial" panose="020B0604020202020204" pitchFamily="34" charset="0"/>
                        </a:rPr>
                        <a:t>閉経後女性</a:t>
                      </a:r>
                      <a:endParaRPr lang="en-US" altLang="ja-JP" sz="2000" b="0" kern="1200" dirty="0">
                        <a:solidFill>
                          <a:schemeClr val="tx1"/>
                        </a:solidFill>
                        <a:effectLst/>
                        <a:latin typeface="+mn-ea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n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7655859"/>
                  </a:ext>
                </a:extLst>
              </a:tr>
              <a:tr h="46912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l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-menopausal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ost-menopausal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141138"/>
                  </a:ext>
                </a:extLst>
              </a:tr>
              <a:tr h="5132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16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19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249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75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2626214"/>
                  </a:ext>
                </a:extLst>
              </a:tr>
              <a:tr h="6515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</a:t>
                      </a:r>
                      <a:r>
                        <a:rPr kumimoji="0" lang="en-US" altLang="ja-JP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erum uric acid</a:t>
                      </a:r>
                      <a:r>
                        <a:rPr lang="ja-JP" altLang="en-US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g/dl)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37±0.01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kern="1200">
                          <a:solidFill>
                            <a:schemeClr val="tx1"/>
                          </a:solidFill>
                          <a:effectLst/>
                          <a:highlight>
                            <a:srgbClr val="00FFFF"/>
                          </a:highlight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11±0.02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0±0.02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05±0.02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0383641"/>
                  </a:ext>
                </a:extLst>
              </a:tr>
              <a:tr h="6515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e (</a:t>
                      </a:r>
                      <a:r>
                        <a:rPr lang="en-US" altLang="ja-JP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years</a:t>
                      </a:r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1.8±0.15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.4±0.12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9.4±0.12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2.9±0.14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50165"/>
                  </a:ext>
                </a:extLst>
              </a:tr>
              <a:tr h="651522"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US" altLang="ja-JP" sz="1800" b="0" kern="1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.4±0.05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.1±0.07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.7±0.06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3.3±0.04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206847"/>
                  </a:ext>
                </a:extLst>
              </a:tr>
              <a:tr h="742795"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cohol </a:t>
                      </a:r>
                      <a:r>
                        <a:rPr lang="en-US" altLang="ja-JP" sz="1800" b="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nsumption</a:t>
                      </a:r>
                      <a:r>
                        <a:rPr lang="en-US" altLang="ja-JP" sz="1800" b="0" kern="100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endParaRPr lang="en-US" altLang="ja-JP" sz="1800" b="0" kern="100" baseline="30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 latinLnBrk="1"/>
                      <a:r>
                        <a:rPr lang="en-US" altLang="ja-JP" sz="18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g/week of pure alcohol)</a:t>
                      </a:r>
                      <a:endParaRPr lang="ja-JP" alt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4160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6.1±1.75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00FFFF"/>
                          </a:highlight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1.0±2.90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2.3±2.03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R="109855" algn="ctr" fontAlgn="ctr"/>
                      <a:r>
                        <a:rPr lang="en-US" sz="18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1.7±3.54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195" marR="3619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263650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57C29043-7074-1C20-E545-5835922D0A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200" y="5215473"/>
            <a:ext cx="9888851" cy="1323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ata for </a:t>
            </a:r>
            <a:r>
              <a:rPr lang="en-US" altLang="ja-JP" sz="16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omen and men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were obtained from population B (n=8891) .</a:t>
            </a:r>
            <a:r>
              <a:rPr kumimoji="0" lang="en-US" altLang="ja-JP" sz="16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ata for pre- and postmenopausal women were from population C (n=4268).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6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esults are expressed as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en-US" altLang="ja-JP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±</a:t>
            </a:r>
            <a:r>
              <a:rPr lang="en-US" altLang="ja-JP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tandard error</a:t>
            </a:r>
            <a:r>
              <a:rPr kumimoji="0" lang="en-US" altLang="ja-JP" sz="16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6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bbreviations: BMI, body mass index.</a:t>
            </a:r>
            <a:endParaRPr kumimoji="0" lang="en-US" altLang="ja-JP" sz="10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30000" dirty="0">
                <a:ln>
                  <a:noFill/>
                </a:ln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 </a:t>
            </a:r>
            <a:r>
              <a:rPr kumimoji="0" lang="en-US" altLang="ja-JP" sz="16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ee Supplementary Table 1 for the calculation of alcohol consumption.</a:t>
            </a:r>
            <a:endParaRPr kumimoji="0" lang="en-US" altLang="ja-JP" sz="10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BCF16C49-52CD-95E2-5385-2BC5691D99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3620" y="353648"/>
            <a:ext cx="9888851" cy="861847"/>
          </a:xfrm>
        </p:spPr>
        <p:txBody>
          <a:bodyPr>
            <a:no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S2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: </a:t>
            </a:r>
            <a:r>
              <a:rPr kumimoji="0" lang="en-US" altLang="ja-JP" sz="1800" b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racteristics of participants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807287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C1AC1E05-3464-26A4-E6FA-6C5791178CD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463668292"/>
              </p:ext>
            </p:extLst>
          </p:nvPr>
        </p:nvGraphicFramePr>
        <p:xfrm>
          <a:off x="458489" y="747475"/>
          <a:ext cx="11235266" cy="4545254"/>
        </p:xfrm>
        <a:graphic>
          <a:graphicData uri="http://schemas.openxmlformats.org/drawingml/2006/table">
            <a:tbl>
              <a:tblPr/>
              <a:tblGrid>
                <a:gridCol w="1605570">
                  <a:extLst>
                    <a:ext uri="{9D8B030D-6E8A-4147-A177-3AD203B41FA5}">
                      <a16:colId xmlns:a16="http://schemas.microsoft.com/office/drawing/2014/main" val="2718658762"/>
                    </a:ext>
                  </a:extLst>
                </a:gridCol>
                <a:gridCol w="68656">
                  <a:extLst>
                    <a:ext uri="{9D8B030D-6E8A-4147-A177-3AD203B41FA5}">
                      <a16:colId xmlns:a16="http://schemas.microsoft.com/office/drawing/2014/main" val="3174205887"/>
                    </a:ext>
                  </a:extLst>
                </a:gridCol>
                <a:gridCol w="589622">
                  <a:extLst>
                    <a:ext uri="{9D8B030D-6E8A-4147-A177-3AD203B41FA5}">
                      <a16:colId xmlns:a16="http://schemas.microsoft.com/office/drawing/2014/main" val="458914860"/>
                    </a:ext>
                  </a:extLst>
                </a:gridCol>
                <a:gridCol w="627466">
                  <a:extLst>
                    <a:ext uri="{9D8B030D-6E8A-4147-A177-3AD203B41FA5}">
                      <a16:colId xmlns:a16="http://schemas.microsoft.com/office/drawing/2014/main" val="4279575941"/>
                    </a:ext>
                  </a:extLst>
                </a:gridCol>
                <a:gridCol w="1005104">
                  <a:extLst>
                    <a:ext uri="{9D8B030D-6E8A-4147-A177-3AD203B41FA5}">
                      <a16:colId xmlns:a16="http://schemas.microsoft.com/office/drawing/2014/main" val="3008851263"/>
                    </a:ext>
                  </a:extLst>
                </a:gridCol>
                <a:gridCol w="162442">
                  <a:extLst>
                    <a:ext uri="{9D8B030D-6E8A-4147-A177-3AD203B41FA5}">
                      <a16:colId xmlns:a16="http://schemas.microsoft.com/office/drawing/2014/main" val="708629976"/>
                    </a:ext>
                  </a:extLst>
                </a:gridCol>
                <a:gridCol w="658709">
                  <a:extLst>
                    <a:ext uri="{9D8B030D-6E8A-4147-A177-3AD203B41FA5}">
                      <a16:colId xmlns:a16="http://schemas.microsoft.com/office/drawing/2014/main" val="423587644"/>
                    </a:ext>
                  </a:extLst>
                </a:gridCol>
                <a:gridCol w="654297">
                  <a:extLst>
                    <a:ext uri="{9D8B030D-6E8A-4147-A177-3AD203B41FA5}">
                      <a16:colId xmlns:a16="http://schemas.microsoft.com/office/drawing/2014/main" val="3527806845"/>
                    </a:ext>
                  </a:extLst>
                </a:gridCol>
                <a:gridCol w="1030057">
                  <a:extLst>
                    <a:ext uri="{9D8B030D-6E8A-4147-A177-3AD203B41FA5}">
                      <a16:colId xmlns:a16="http://schemas.microsoft.com/office/drawing/2014/main" val="2339356050"/>
                    </a:ext>
                  </a:extLst>
                </a:gridCol>
                <a:gridCol w="88039">
                  <a:extLst>
                    <a:ext uri="{9D8B030D-6E8A-4147-A177-3AD203B41FA5}">
                      <a16:colId xmlns:a16="http://schemas.microsoft.com/office/drawing/2014/main" val="3354981753"/>
                    </a:ext>
                  </a:extLst>
                </a:gridCol>
                <a:gridCol w="677900">
                  <a:extLst>
                    <a:ext uri="{9D8B030D-6E8A-4147-A177-3AD203B41FA5}">
                      <a16:colId xmlns:a16="http://schemas.microsoft.com/office/drawing/2014/main" val="3885436197"/>
                    </a:ext>
                  </a:extLst>
                </a:gridCol>
                <a:gridCol w="589861">
                  <a:extLst>
                    <a:ext uri="{9D8B030D-6E8A-4147-A177-3AD203B41FA5}">
                      <a16:colId xmlns:a16="http://schemas.microsoft.com/office/drawing/2014/main" val="3988751345"/>
                    </a:ext>
                  </a:extLst>
                </a:gridCol>
                <a:gridCol w="1003645">
                  <a:extLst>
                    <a:ext uri="{9D8B030D-6E8A-4147-A177-3AD203B41FA5}">
                      <a16:colId xmlns:a16="http://schemas.microsoft.com/office/drawing/2014/main" val="1184159709"/>
                    </a:ext>
                  </a:extLst>
                </a:gridCol>
                <a:gridCol w="264117">
                  <a:extLst>
                    <a:ext uri="{9D8B030D-6E8A-4147-A177-3AD203B41FA5}">
                      <a16:colId xmlns:a16="http://schemas.microsoft.com/office/drawing/2014/main" val="169163604"/>
                    </a:ext>
                  </a:extLst>
                </a:gridCol>
                <a:gridCol w="642685">
                  <a:extLst>
                    <a:ext uri="{9D8B030D-6E8A-4147-A177-3AD203B41FA5}">
                      <a16:colId xmlns:a16="http://schemas.microsoft.com/office/drawing/2014/main" val="3723810495"/>
                    </a:ext>
                  </a:extLst>
                </a:gridCol>
                <a:gridCol w="607471">
                  <a:extLst>
                    <a:ext uri="{9D8B030D-6E8A-4147-A177-3AD203B41FA5}">
                      <a16:colId xmlns:a16="http://schemas.microsoft.com/office/drawing/2014/main" val="4258429447"/>
                    </a:ext>
                  </a:extLst>
                </a:gridCol>
                <a:gridCol w="959625">
                  <a:extLst>
                    <a:ext uri="{9D8B030D-6E8A-4147-A177-3AD203B41FA5}">
                      <a16:colId xmlns:a16="http://schemas.microsoft.com/office/drawing/2014/main" val="241710141"/>
                    </a:ext>
                  </a:extLst>
                </a:gridCol>
              </a:tblGrid>
              <a:tr h="31731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CG2</a:t>
                      </a:r>
                      <a:r>
                        <a:rPr lang="en-US" altLang="ja-JP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function</a:t>
                      </a:r>
                      <a:endParaRPr lang="ja-JP" altLang="en-US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ja-JP" sz="16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ja-JP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omen</a:t>
                      </a:r>
                      <a:endParaRPr lang="ja-JP" alt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US" altLang="ja-JP" sz="16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gridSpan="3">
                  <a:txBody>
                    <a:bodyPr/>
                    <a:lstStyle/>
                    <a:p>
                      <a:pPr algn="ctr"/>
                      <a:endParaRPr lang="en-US" altLang="ja-JP" sz="1600" b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altLang="ja-JP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n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3122229"/>
                  </a:ext>
                </a:extLst>
              </a:tr>
              <a:tr h="28956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l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ja-JP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menopausal</a:t>
                      </a: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ja-JP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ostmenopausal</a:t>
                      </a:r>
                    </a:p>
                  </a:txBody>
                  <a:tcPr marL="84174" marR="84174" marT="42087" marB="42087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2394157"/>
                  </a:ext>
                </a:extLst>
              </a:tr>
              <a:tr h="47909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1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l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altLang="ja-JP" sz="1600" b="0" i="0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alt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endParaRPr lang="en-US" altLang="ja-JP" sz="1600" b="0" i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A</a:t>
                      </a: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g/dl)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1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l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altLang="ja-JP" sz="1600" b="0" i="0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alt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endParaRPr lang="en-US" altLang="ja-JP" sz="1600" b="0" i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A</a:t>
                      </a: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g/dl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1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l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altLang="ja-JP" sz="1600" b="0" i="0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alt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endParaRPr lang="en-US" altLang="ja-JP" sz="1600" b="0" i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A</a:t>
                      </a: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g/dl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1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l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altLang="ja-JP" sz="1600" b="0" i="0" kern="1200" baseline="-25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alt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1600" b="0" i="0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endParaRPr lang="en-US" altLang="ja-JP" sz="1600" b="0" i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%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A</a:t>
                      </a:r>
                    </a:p>
                    <a:p>
                      <a:pPr algn="ctr" fontAlgn="ctr"/>
                      <a:r>
                        <a:rPr lang="en-US" sz="16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g/dl)</a:t>
                      </a:r>
                      <a:endParaRPr lang="ja-JP" sz="1600" b="0" i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0991941"/>
                  </a:ext>
                </a:extLst>
              </a:tr>
              <a:tr h="7825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ull function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08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5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08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5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26±0.0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3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2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3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2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00±0.03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53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8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53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8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49±0.03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240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6.9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96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8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90±0.0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2382330"/>
                  </a:ext>
                </a:extLst>
              </a:tr>
              <a:tr h="689349"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/4 function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 latinLnBrk="1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ild dysfunction)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29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0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28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0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42±0.02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6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07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0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07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0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15±0.03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04</a:t>
                      </a:r>
                    </a:p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0.1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03</a:t>
                      </a:r>
                    </a:p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40.2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6±0.03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81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39.4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88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39.1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16±0.03</a:t>
                      </a: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1549966"/>
                  </a:ext>
                </a:extLst>
              </a:tr>
              <a:tr h="710855"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/2 function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 latinLnBrk="1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moderate </a:t>
                      </a:r>
                    </a:p>
                    <a:p>
                      <a:pPr algn="ctr" fontAlgn="ctr" latinLnBrk="1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ysfunction)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30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2.3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29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2.3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53±0.04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6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3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3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3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3.0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33±0.06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1.7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1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1.6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73±0.06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90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2.3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29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1.6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27±0.06</a:t>
                      </a: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8204840"/>
                  </a:ext>
                </a:extLst>
              </a:tr>
              <a:tr h="5901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≤1/4 function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4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severe dysfunction)</a:t>
                      </a:r>
                      <a:endParaRPr lang="ja-JP" sz="14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1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.2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1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.2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85±0.15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0.8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0.8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34±0.21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.4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.4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13±0.19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7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.4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.3)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40±0.16</a:t>
                      </a: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0165881"/>
                  </a:ext>
                </a:extLst>
              </a:tr>
              <a:tr h="5604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otal </a:t>
                      </a:r>
                      <a:endParaRPr lang="ja-JP" altLang="en-US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18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16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37±0.01</a:t>
                      </a: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19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19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11±0.0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251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249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.60±</a:t>
                      </a:r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1628" marR="21628" marT="876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778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75</a:t>
                      </a:r>
                      <a:endParaRPr lang="ja-JP" sz="16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kern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05±0.02</a:t>
                      </a:r>
                    </a:p>
                  </a:txBody>
                  <a:tcPr marL="23495" marR="2349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222411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19D4FDA-0734-C8B6-2BFD-17516B375FB0}"/>
              </a:ext>
            </a:extLst>
          </p:cNvPr>
          <p:cNvSpPr txBox="1"/>
          <p:nvPr/>
        </p:nvSpPr>
        <p:spPr>
          <a:xfrm>
            <a:off x="555222" y="5292729"/>
            <a:ext cx="1121591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A is expressed as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an + standard error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  <p:sp>
        <p:nvSpPr>
          <p:cNvPr id="9" name="タイトル 1">
            <a:extLst>
              <a:ext uri="{FF2B5EF4-FFF2-40B4-BE49-F238E27FC236}">
                <a16:creationId xmlns:a16="http://schemas.microsoft.com/office/drawing/2014/main" id="{675CD4B7-8CD3-CA20-4AF6-0EEE9B987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4143" y="0"/>
            <a:ext cx="11617423" cy="861304"/>
          </a:xfrm>
        </p:spPr>
        <p:txBody>
          <a:bodyPr/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</a:t>
            </a:r>
            <a:r>
              <a:rPr lang="en-US" altLang="ja-JP" sz="1800" b="1" dirty="0">
                <a:latin typeface="Arial" panose="020B0604020202020204" pitchFamily="34" charset="0"/>
                <a:ea typeface="ＭＳ 明朝" panose="02020609040205080304" pitchFamily="17" charset="-128"/>
              </a:rPr>
              <a:t>upplementary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Table S3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: Serum uric acid (SUA) in each ABCG2 functional group estimated from the combination of dysfunctional variants</a:t>
            </a:r>
            <a:endParaRPr kumimoji="1" lang="ja-JP" altLang="en-US" dirty="0"/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24A7ADAF-213B-B596-08B3-B0D2A811FC29}"/>
              </a:ext>
            </a:extLst>
          </p:cNvPr>
          <p:cNvSpPr txBox="1">
            <a:spLocks/>
          </p:cNvSpPr>
          <p:nvPr/>
        </p:nvSpPr>
        <p:spPr>
          <a:xfrm>
            <a:off x="555222" y="5532959"/>
            <a:ext cx="11235266" cy="674031"/>
          </a:xfrm>
          <a:prstGeom prst="rect">
            <a:avLst/>
          </a:prstGeom>
        </p:spPr>
        <p:txBody>
          <a:bodyPr vert="horz" wrap="square" lIns="91440" tIns="45720" rIns="91440" bIns="45720" rtlCol="0" anchor="b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400" baseline="30000" dirty="0">
                <a:latin typeface="Arial" panose="020B0604020202020204" pitchFamily="34" charset="0"/>
                <a:ea typeface="ＭＳ Ｐゴシック" panose="020B0600070205080204" pitchFamily="50" charset="-128"/>
              </a:rPr>
              <a:t>a</a:t>
            </a:r>
            <a:r>
              <a:rPr lang="en-US" altLang="ja-JP" sz="1400" kern="1200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</a:rPr>
              <a:t> </a:t>
            </a:r>
            <a:r>
              <a:rPr lang="en-US" altLang="ja-JP" sz="1400" kern="12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</a:rPr>
              <a:t>“</a:t>
            </a:r>
            <a:r>
              <a:rPr lang="en-US" altLang="ja-JP" sz="1400" i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</a:t>
            </a:r>
            <a:r>
              <a:rPr lang="en-US" altLang="ja-JP" sz="1400" i="1" baseline="-250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ll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” represents the number of each participant from population A (n=9096), while “</a:t>
            </a:r>
            <a:r>
              <a:rPr lang="en-US" altLang="ja-JP" sz="1400" i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” represents the number of each participant from population B (</a:t>
            </a:r>
            <a:r>
              <a:rPr lang="en-US" altLang="ja-JP" sz="1400" dirty="0">
                <a:latin typeface="Arial" panose="020B0604020202020204" pitchFamily="34" charset="0"/>
                <a:ea typeface="ＭＳ 明朝" panose="02020609040205080304" pitchFamily="17" charset="-128"/>
              </a:rPr>
              <a:t>n=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8891)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or pre- and postmenopausal women, </a:t>
            </a:r>
            <a:r>
              <a:rPr lang="en-US" altLang="ja-JP" sz="1400" kern="12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</a:rPr>
              <a:t>“</a:t>
            </a:r>
            <a:r>
              <a:rPr lang="en-US" altLang="ja-JP" sz="1400" i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</a:t>
            </a:r>
            <a:r>
              <a:rPr lang="en-US" altLang="ja-JP" sz="1400" i="1" baseline="-250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ll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” represents the number of each participant from 4270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 whose information for 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menopausa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status was available. </a:t>
            </a:r>
            <a:r>
              <a:rPr lang="en-US" altLang="ja-JP" sz="1400" baseline="30000" dirty="0">
                <a:latin typeface="Arial" panose="020B0604020202020204" pitchFamily="34" charset="0"/>
                <a:ea typeface="ＭＳ Ｐゴシック" panose="020B0600070205080204" pitchFamily="50" charset="-128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</a:rPr>
              <a:t>“</a:t>
            </a:r>
            <a:r>
              <a:rPr lang="en-US" altLang="ja-JP" sz="1400" i="1" dirty="0">
                <a:latin typeface="Arial" panose="020B0604020202020204" pitchFamily="34" charset="0"/>
                <a:ea typeface="ＭＳ 明朝" panose="02020609040205080304" pitchFamily="17" charset="-128"/>
              </a:rPr>
              <a:t>N</a:t>
            </a:r>
            <a:r>
              <a:rPr lang="en-US" altLang="ja-JP" sz="1400" dirty="0">
                <a:latin typeface="Arial" panose="020B0604020202020204" pitchFamily="34" charset="0"/>
                <a:ea typeface="ＭＳ 明朝" panose="02020609040205080304" pitchFamily="17" charset="-128"/>
              </a:rPr>
              <a:t>” represents 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the number of each participant from </a:t>
            </a:r>
            <a:r>
              <a:rPr lang="en-US" altLang="ja-JP" sz="1400" dirty="0">
                <a:latin typeface="Arial" panose="020B0604020202020204" pitchFamily="34" charset="0"/>
                <a:ea typeface="ＭＳ 明朝" panose="02020609040205080304" pitchFamily="17" charset="-128"/>
              </a:rPr>
              <a:t>population C (n=4268).</a:t>
            </a:r>
            <a:endParaRPr lang="en-US" altLang="ja-JP" sz="14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6594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コンテンツ プレースホルダー 20">
            <a:extLst>
              <a:ext uri="{FF2B5EF4-FFF2-40B4-BE49-F238E27FC236}">
                <a16:creationId xmlns:a16="http://schemas.microsoft.com/office/drawing/2014/main" id="{79601024-B44A-7BBD-C539-93F52EDF8E4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59320743"/>
              </p:ext>
            </p:extLst>
          </p:nvPr>
        </p:nvGraphicFramePr>
        <p:xfrm>
          <a:off x="661853" y="20883"/>
          <a:ext cx="11530147" cy="54671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EF6C1A1-7E47-76CF-0346-E585806E5C39}"/>
              </a:ext>
            </a:extLst>
          </p:cNvPr>
          <p:cNvSpPr txBox="1"/>
          <p:nvPr/>
        </p:nvSpPr>
        <p:spPr>
          <a:xfrm>
            <a:off x="1867954" y="4945251"/>
            <a:ext cx="98319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       (n=1985)                  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　    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n=1710)                                (n=524)                                   (n=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テキスト ボックス 2">
            <a:extLst>
              <a:ext uri="{FF2B5EF4-FFF2-40B4-BE49-F238E27FC236}">
                <a16:creationId xmlns:a16="http://schemas.microsoft.com/office/drawing/2014/main" id="{6BC0694E-4FEF-871B-7E66-DE27F4EB0771}"/>
              </a:ext>
            </a:extLst>
          </p:cNvPr>
          <p:cNvSpPr txBox="1"/>
          <p:nvPr/>
        </p:nvSpPr>
        <p:spPr>
          <a:xfrm>
            <a:off x="9659536" y="584665"/>
            <a:ext cx="2233669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700" dirty="0">
                <a:latin typeface="Arial" panose="020B0604020202020204" pitchFamily="34" charset="0"/>
                <a:cs typeface="Arial" panose="020B0604020202020204" pitchFamily="34" charset="0"/>
              </a:rPr>
              <a:t>β= 0.79</a:t>
            </a:r>
          </a:p>
          <a:p>
            <a:pPr algn="ctr"/>
            <a:r>
              <a:rPr kumimoji="1" lang="en-US" altLang="ja-JP" sz="1700" dirty="0">
                <a:latin typeface="Arial" panose="020B0604020202020204" pitchFamily="34" charset="0"/>
                <a:cs typeface="Arial" panose="020B0604020202020204" pitchFamily="34" charset="0"/>
              </a:rPr>
              <a:t> (p=0.014</a:t>
            </a:r>
            <a:r>
              <a:rPr lang="en-US" altLang="ja-JP" sz="1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en-US" altLang="ja-JP" sz="1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スライド番号プレースホルダー 2">
            <a:extLst>
              <a:ext uri="{FF2B5EF4-FFF2-40B4-BE49-F238E27FC236}">
                <a16:creationId xmlns:a16="http://schemas.microsoft.com/office/drawing/2014/main" id="{74D1D6A3-D723-2AA7-40BB-01B26CC3F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262221"/>
            <a:ext cx="2743200" cy="365125"/>
          </a:xfrm>
        </p:spPr>
        <p:txBody>
          <a:bodyPr/>
          <a:lstStyle/>
          <a:p>
            <a:fld id="{5A56B9AE-3D0A-45F5-8F0B-3E4713A3ED06}" type="slidenum">
              <a:rPr kumimoji="1" lang="ja-JP" altLang="en-US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fld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3373C4B0-597F-B212-E005-9C276E68E1DF}"/>
              </a:ext>
            </a:extLst>
          </p:cNvPr>
          <p:cNvSpPr/>
          <p:nvPr/>
        </p:nvSpPr>
        <p:spPr>
          <a:xfrm>
            <a:off x="1275114" y="427648"/>
            <a:ext cx="160953" cy="43645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タイトル 1">
            <a:extLst>
              <a:ext uri="{FF2B5EF4-FFF2-40B4-BE49-F238E27FC236}">
                <a16:creationId xmlns:a16="http://schemas.microsoft.com/office/drawing/2014/main" id="{9CDDB2BE-5496-AFC2-A750-C0F68BBC9631}"/>
              </a:ext>
            </a:extLst>
          </p:cNvPr>
          <p:cNvSpPr txBox="1">
            <a:spLocks/>
          </p:cNvSpPr>
          <p:nvPr/>
        </p:nvSpPr>
        <p:spPr>
          <a:xfrm>
            <a:off x="853308" y="5410217"/>
            <a:ext cx="11153916" cy="1110928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600" b="1" dirty="0">
                <a:latin typeface="Arial" panose="020B0604020202020204" pitchFamily="34" charset="0"/>
                <a:ea typeface="ＭＳ 明朝" panose="02020609040205080304" pitchFamily="17" charset="-128"/>
              </a:rPr>
              <a:t>Supplementary Figure 1</a:t>
            </a:r>
            <a:r>
              <a:rPr lang="en-US" altLang="ja-JP" sz="1600" dirty="0">
                <a:latin typeface="Arial" panose="020B0604020202020204" pitchFamily="34" charset="0"/>
                <a:ea typeface="ＭＳ 明朝" panose="02020609040205080304" pitchFamily="17" charset="-128"/>
              </a:rPr>
              <a:t>: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ffects of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enopause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on serum uric acid (SUA) levels of women for each ABCG2 function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A levels of pre- and postmenopausal women (population C) were shown for each ABCG2 function.  </a:t>
            </a:r>
            <a:endParaRPr lang="en-US" altLang="ja-JP" sz="1600" kern="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r>
              <a:rPr lang="en-US" altLang="ja-JP" sz="16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A is expressed as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ean + standard error.</a:t>
            </a:r>
          </a:p>
          <a:p>
            <a:r>
              <a:rPr lang="el-GR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represents regression coefficient for each simple linear regression analysis.</a:t>
            </a:r>
          </a:p>
        </p:txBody>
      </p:sp>
      <p:sp>
        <p:nvSpPr>
          <p:cNvPr id="2" name="テキスト ボックス 9">
            <a:extLst>
              <a:ext uri="{FF2B5EF4-FFF2-40B4-BE49-F238E27FC236}">
                <a16:creationId xmlns:a16="http://schemas.microsoft.com/office/drawing/2014/main" id="{C2D124B7-62D9-8DF9-8F34-05C87C0C794B}"/>
              </a:ext>
            </a:extLst>
          </p:cNvPr>
          <p:cNvSpPr txBox="1"/>
          <p:nvPr/>
        </p:nvSpPr>
        <p:spPr>
          <a:xfrm>
            <a:off x="1867954" y="872828"/>
            <a:ext cx="314946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meno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ausal                    postmenopausal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women                                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97067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6">
            <a:extLst>
              <a:ext uri="{FF2B5EF4-FFF2-40B4-BE49-F238E27FC236}">
                <a16:creationId xmlns:a16="http://schemas.microsoft.com/office/drawing/2014/main" id="{5888FB9B-F726-28AA-A9AE-FDED12235BB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35459041"/>
              </p:ext>
            </p:extLst>
          </p:nvPr>
        </p:nvGraphicFramePr>
        <p:xfrm>
          <a:off x="761371" y="110465"/>
          <a:ext cx="10429946" cy="5720104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1520614">
                  <a:extLst>
                    <a:ext uri="{9D8B030D-6E8A-4147-A177-3AD203B41FA5}">
                      <a16:colId xmlns:a16="http://schemas.microsoft.com/office/drawing/2014/main" val="1191290576"/>
                    </a:ext>
                  </a:extLst>
                </a:gridCol>
                <a:gridCol w="1905702">
                  <a:extLst>
                    <a:ext uri="{9D8B030D-6E8A-4147-A177-3AD203B41FA5}">
                      <a16:colId xmlns:a16="http://schemas.microsoft.com/office/drawing/2014/main" val="4110816848"/>
                    </a:ext>
                  </a:extLst>
                </a:gridCol>
                <a:gridCol w="1716156">
                  <a:extLst>
                    <a:ext uri="{9D8B030D-6E8A-4147-A177-3AD203B41FA5}">
                      <a16:colId xmlns:a16="http://schemas.microsoft.com/office/drawing/2014/main" val="2768423499"/>
                    </a:ext>
                  </a:extLst>
                </a:gridCol>
                <a:gridCol w="1810826">
                  <a:extLst>
                    <a:ext uri="{9D8B030D-6E8A-4147-A177-3AD203B41FA5}">
                      <a16:colId xmlns:a16="http://schemas.microsoft.com/office/drawing/2014/main" val="2032810145"/>
                    </a:ext>
                  </a:extLst>
                </a:gridCol>
                <a:gridCol w="1738324">
                  <a:extLst>
                    <a:ext uri="{9D8B030D-6E8A-4147-A177-3AD203B41FA5}">
                      <a16:colId xmlns:a16="http://schemas.microsoft.com/office/drawing/2014/main" val="337757444"/>
                    </a:ext>
                  </a:extLst>
                </a:gridCol>
                <a:gridCol w="1738324">
                  <a:extLst>
                    <a:ext uri="{9D8B030D-6E8A-4147-A177-3AD203B41FA5}">
                      <a16:colId xmlns:a16="http://schemas.microsoft.com/office/drawing/2014/main" val="2089103874"/>
                    </a:ext>
                  </a:extLst>
                </a:gridCol>
              </a:tblGrid>
              <a:tr h="426720"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G2</a:t>
                      </a:r>
                      <a:r>
                        <a:rPr kumimoji="1" lang="ja-JP" altLang="en-US" sz="1600" b="0" i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nts</a:t>
                      </a:r>
                      <a:endParaRPr kumimoji="1" lang="ja-JP" altLang="en-US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ing</a:t>
                      </a:r>
                      <a:endParaRPr kumimoji="1" lang="ja-JP" altLang="en-US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vy</a:t>
                      </a:r>
                      <a:r>
                        <a:rPr kumimoji="1" lang="ja-JP" altLang="en-US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nking</a:t>
                      </a:r>
                      <a:endParaRPr kumimoji="1" lang="ja-JP" altLang="en-US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weight/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esity</a:t>
                      </a:r>
                      <a:endParaRPr kumimoji="1" lang="ja-JP" altLang="en-US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6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 menopause</a:t>
                      </a:r>
                    </a:p>
                  </a:txBody>
                  <a:tcPr marT="0" marB="0"/>
                </a:tc>
                <a:extLst>
                  <a:ext uri="{0D108BD9-81ED-4DB2-BD59-A6C34878D82A}">
                    <a16:rowId xmlns:a16="http://schemas.microsoft.com/office/drawing/2014/main" val="3202706899"/>
                  </a:ext>
                </a:extLst>
              </a:tr>
              <a:tr h="1308106">
                <a:tc>
                  <a:txBody>
                    <a:bodyPr/>
                    <a:lstStyle/>
                    <a:p>
                      <a:pPr algn="ctr"/>
                      <a:endParaRPr kumimoji="1" lang="en-US" altLang="ja-JP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/>
                      <a:r>
                        <a:rPr kumimoji="1" lang="ja-JP" altLang="en-US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omen</a:t>
                      </a:r>
                    </a:p>
                    <a:p>
                      <a:pPr algn="ctr"/>
                      <a:endParaRPr kumimoji="1" lang="en-US" altLang="ja-JP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318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/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447414"/>
                  </a:ext>
                </a:extLst>
              </a:tr>
              <a:tr h="1308106">
                <a:tc>
                  <a:txBody>
                    <a:bodyPr/>
                    <a:lstStyle/>
                    <a:p>
                      <a:pPr algn="ctr"/>
                      <a:endParaRPr kumimoji="1" lang="en-US" altLang="ja-JP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</a:t>
                      </a:r>
                    </a:p>
                    <a:p>
                      <a:pPr algn="ctr"/>
                      <a:r>
                        <a:rPr kumimoji="1" lang="en-US" altLang="ja-JP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opausal</a:t>
                      </a:r>
                    </a:p>
                    <a:p>
                      <a:pPr algn="ctr"/>
                      <a:endParaRPr kumimoji="1" lang="en-US" altLang="ja-JP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019)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kumimoji="1" lang="en-US" altLang="ja-JP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one 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s over 60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3646937"/>
                  </a:ext>
                </a:extLst>
              </a:tr>
              <a:tr h="1308106">
                <a:tc>
                  <a:txBody>
                    <a:bodyPr/>
                    <a:lstStyle/>
                    <a:p>
                      <a:pPr algn="ctr"/>
                      <a:endParaRPr kumimoji="1" lang="en-US" altLang="ja-JP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</a:t>
                      </a:r>
                    </a:p>
                    <a:p>
                      <a:pPr algn="ctr"/>
                      <a:r>
                        <a:rPr kumimoji="1" lang="en-US" altLang="ja-JP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opausal</a:t>
                      </a:r>
                      <a:endParaRPr kumimoji="1" lang="en-US" altLang="ja-JP" sz="1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kumimoji="1" lang="en-US" altLang="ja-JP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25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5767446"/>
                  </a:ext>
                </a:extLst>
              </a:tr>
              <a:tr h="1308106">
                <a:tc>
                  <a:txBody>
                    <a:bodyPr/>
                    <a:lstStyle/>
                    <a:p>
                      <a:pPr algn="ctr"/>
                      <a:endParaRPr kumimoji="1" lang="en-US" altLang="ja-JP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/>
                      <a:r>
                        <a:rPr kumimoji="1" lang="ja-JP" altLang="en-US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  </a:t>
                      </a:r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</a:t>
                      </a:r>
                      <a:endParaRPr kumimoji="1" lang="en-US" altLang="ja-JP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kumimoji="1" lang="en-US" altLang="ja-JP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778)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0700223"/>
                  </a:ext>
                </a:extLst>
              </a:tr>
            </a:tbl>
          </a:graphicData>
        </a:graphic>
      </p:graphicFrame>
      <p:sp>
        <p:nvSpPr>
          <p:cNvPr id="22" name="タイトル 1">
            <a:extLst>
              <a:ext uri="{FF2B5EF4-FFF2-40B4-BE49-F238E27FC236}">
                <a16:creationId xmlns:a16="http://schemas.microsoft.com/office/drawing/2014/main" id="{0C816D83-05EA-5F61-30F2-3692052078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3831" y="6035695"/>
            <a:ext cx="10429946" cy="824710"/>
          </a:xfrm>
        </p:spPr>
        <p:txBody>
          <a:bodyPr>
            <a:normAutofit fontScale="90000"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ea typeface="ＭＳ 明朝" panose="02020609040205080304" pitchFamily="17" charset="-128"/>
              </a:rPr>
              <a:t>Supplementary Figure 2</a:t>
            </a:r>
            <a:r>
              <a:rPr lang="en-US" altLang="ja-JP" sz="2000" dirty="0">
                <a:latin typeface="Arial" panose="020B0604020202020204" pitchFamily="34" charset="0"/>
                <a:ea typeface="ＭＳ 明朝" panose="02020609040205080304" pitchFamily="17" charset="-128"/>
              </a:rPr>
              <a:t>: </a:t>
            </a:r>
            <a:r>
              <a:rPr lang="en-US" altLang="ja-JP" sz="20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PAF </a:t>
            </a:r>
            <a:r>
              <a:rPr lang="en-US" altLang="ja-JP" sz="2000" dirty="0">
                <a:latin typeface="Arial" panose="020B0604020202020204" pitchFamily="34" charset="0"/>
                <a:ea typeface="ＭＳ 明朝" panose="02020609040205080304" pitchFamily="17" charset="-128"/>
              </a:rPr>
              <a:t>of</a:t>
            </a:r>
            <a:r>
              <a:rPr lang="en-US" altLang="ja-JP" sz="20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each risk factor for hyperuricemia progression</a:t>
            </a:r>
            <a:b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</a:b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ja-JP" sz="16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women and men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, PAF was calculated in population A (n=9096). For pre- and post-menopausal women, those were calculated in 4270 women whose menstrual status was known among population A. </a:t>
            </a:r>
            <a:r>
              <a:rPr kumimoji="0" lang="en-US" altLang="ja-JP" sz="16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sults whose 95% confidence intervals straddle zero are indicated by circles with dashed lines.</a:t>
            </a:r>
            <a:br>
              <a:rPr lang="en-US" altLang="ja-JP" sz="1600" kern="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6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bbreviation: PAF, population attributable fraction</a:t>
            </a:r>
            <a:br>
              <a:rPr lang="ja-JP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</a:b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594B9D4A-B40E-800D-884C-2B7B25A2BC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2578089"/>
              </p:ext>
            </p:extLst>
          </p:nvPr>
        </p:nvGraphicFramePr>
        <p:xfrm>
          <a:off x="2257557" y="1820802"/>
          <a:ext cx="1931760" cy="14714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07F49CE5-1F0B-C798-11D7-F5E9796325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2807501"/>
              </p:ext>
            </p:extLst>
          </p:nvPr>
        </p:nvGraphicFramePr>
        <p:xfrm>
          <a:off x="2257557" y="519947"/>
          <a:ext cx="1931760" cy="14714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0818BAC8-6ADC-DE06-2BA9-AF2ECE140E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7932641"/>
              </p:ext>
            </p:extLst>
          </p:nvPr>
        </p:nvGraphicFramePr>
        <p:xfrm>
          <a:off x="3883622" y="517101"/>
          <a:ext cx="2340337" cy="147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B46D275E-EF8D-DA29-BDBE-9727EBF44A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381938"/>
              </p:ext>
            </p:extLst>
          </p:nvPr>
        </p:nvGraphicFramePr>
        <p:xfrm>
          <a:off x="5815381" y="522698"/>
          <a:ext cx="2165611" cy="1468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CB70477C-667F-7B1B-B312-508D8507D6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4347879"/>
              </p:ext>
            </p:extLst>
          </p:nvPr>
        </p:nvGraphicFramePr>
        <p:xfrm>
          <a:off x="9249066" y="517099"/>
          <a:ext cx="2281566" cy="1468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ECA901A2-EE61-F2A9-FFCB-3022E249AE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0271939"/>
              </p:ext>
            </p:extLst>
          </p:nvPr>
        </p:nvGraphicFramePr>
        <p:xfrm>
          <a:off x="7535112" y="1820803"/>
          <a:ext cx="2283828" cy="1475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94E62507-2359-8E40-0351-15FFF90D4D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2556298"/>
              </p:ext>
            </p:extLst>
          </p:nvPr>
        </p:nvGraphicFramePr>
        <p:xfrm>
          <a:off x="2257557" y="3137371"/>
          <a:ext cx="1931760" cy="14654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96FE35E1-E0F0-E71A-3844-D55635A60B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7171200"/>
              </p:ext>
            </p:extLst>
          </p:nvPr>
        </p:nvGraphicFramePr>
        <p:xfrm>
          <a:off x="3972229" y="3139663"/>
          <a:ext cx="2340337" cy="14715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012B2FA9-6B19-29B6-04E1-D7D19A1269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5739273"/>
              </p:ext>
            </p:extLst>
          </p:nvPr>
        </p:nvGraphicFramePr>
        <p:xfrm>
          <a:off x="5810177" y="3141343"/>
          <a:ext cx="2170114" cy="14716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E3507A79-C3A6-ADB3-05CA-D317EE217D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6961835"/>
              </p:ext>
            </p:extLst>
          </p:nvPr>
        </p:nvGraphicFramePr>
        <p:xfrm>
          <a:off x="7535112" y="3146659"/>
          <a:ext cx="2282200" cy="14561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76B388A1-3AF5-FB78-EBB8-80FC568B8A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4563352"/>
              </p:ext>
            </p:extLst>
          </p:nvPr>
        </p:nvGraphicFramePr>
        <p:xfrm>
          <a:off x="2262760" y="4454922"/>
          <a:ext cx="1931760" cy="1468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F89E2EBE-E284-1B9C-02B9-2ED151EB70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2333876"/>
              </p:ext>
            </p:extLst>
          </p:nvPr>
        </p:nvGraphicFramePr>
        <p:xfrm>
          <a:off x="3998957" y="4446595"/>
          <a:ext cx="2182870" cy="1468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201155FE-DE85-0E29-FA9F-F2194244B5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2210869"/>
              </p:ext>
            </p:extLst>
          </p:nvPr>
        </p:nvGraphicFramePr>
        <p:xfrm>
          <a:off x="5815381" y="4458635"/>
          <a:ext cx="2164910" cy="1503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C1BE8F2C-5C42-7FED-A310-F5723FB8C0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672670"/>
              </p:ext>
            </p:extLst>
          </p:nvPr>
        </p:nvGraphicFramePr>
        <p:xfrm>
          <a:off x="7581495" y="4454922"/>
          <a:ext cx="2282200" cy="1503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D2115057-1FD3-B3C5-5A30-A85D916E02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9564521"/>
              </p:ext>
            </p:extLst>
          </p:nvPr>
        </p:nvGraphicFramePr>
        <p:xfrm>
          <a:off x="5815381" y="1772825"/>
          <a:ext cx="2165611" cy="1523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42A1DDDB-4C3A-7E16-BCCE-0931E01FE8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332451"/>
              </p:ext>
            </p:extLst>
          </p:nvPr>
        </p:nvGraphicFramePr>
        <p:xfrm>
          <a:off x="7536739" y="517100"/>
          <a:ext cx="2280572" cy="1503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</p:spTree>
    <p:extLst>
      <p:ext uri="{BB962C8B-B14F-4D97-AF65-F5344CB8AC3E}">
        <p14:creationId xmlns:p14="http://schemas.microsoft.com/office/powerpoint/2010/main" val="2959050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79</TotalTime>
  <Words>1084</Words>
  <Application>Microsoft Office PowerPoint</Application>
  <PresentationFormat>ワイド画面</PresentationFormat>
  <Paragraphs>340</Paragraphs>
  <Slides>6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游ゴシック</vt:lpstr>
      <vt:lpstr>游ゴシック Light</vt:lpstr>
      <vt:lpstr>Arial</vt:lpstr>
      <vt:lpstr>Times New Roman</vt:lpstr>
      <vt:lpstr>Office テーマ</vt:lpstr>
      <vt:lpstr>Supplementary Information </vt:lpstr>
      <vt:lpstr>Supplementary Table 1: Conversion table of alcohol consumption</vt:lpstr>
      <vt:lpstr>Supplementary Table S2: Characteristics of participants</vt:lpstr>
      <vt:lpstr>Supplementary Table S3: Serum uric acid (SUA) in each ABCG2 functional group estimated from the combination of dysfunctional variants</vt:lpstr>
      <vt:lpstr>PowerPoint プレゼンテーション</vt:lpstr>
      <vt:lpstr>Supplementary Figure 2: PAF of each risk factor for hyperuricemia progression For women and men, PAF was calculated in population A (n=9096). For pre- and post-menopausal women, those were calculated in 4270 women whose menstrual status was known among population A. Results whose 95% confidence intervals straddle zero are indicated by circles with dashed lines. Abbreviation: PAF, population attributable fraction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優香 三好</dc:creator>
  <cp:lastModifiedBy>優香 三好</cp:lastModifiedBy>
  <cp:revision>97</cp:revision>
  <cp:lastPrinted>2023-09-28T07:07:10Z</cp:lastPrinted>
  <dcterms:created xsi:type="dcterms:W3CDTF">2023-04-26T05:38:46Z</dcterms:created>
  <dcterms:modified xsi:type="dcterms:W3CDTF">2026-04-28T22:31:38Z</dcterms:modified>
</cp:coreProperties>
</file>